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8" r:id="rId5"/>
    <p:sldId id="270" r:id="rId6"/>
    <p:sldId id="257" r:id="rId7"/>
    <p:sldId id="269" r:id="rId8"/>
    <p:sldId id="260" r:id="rId9"/>
    <p:sldId id="272" r:id="rId10"/>
    <p:sldId id="259" r:id="rId11"/>
    <p:sldId id="271" r:id="rId12"/>
    <p:sldId id="261" r:id="rId13"/>
    <p:sldId id="273" r:id="rId14"/>
    <p:sldId id="274" r:id="rId15"/>
    <p:sldId id="275" r:id="rId16"/>
    <p:sldId id="263" r:id="rId17"/>
    <p:sldId id="276" r:id="rId18"/>
    <p:sldId id="264" r:id="rId19"/>
    <p:sldId id="265" r:id="rId20"/>
    <p:sldId id="266" r:id="rId21"/>
    <p:sldId id="267" r:id="rId22"/>
    <p:sldId id="268" r:id="rId2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 mitjà 2 - èmfasi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8527" autoAdjust="0"/>
    <p:restoredTop sz="94660"/>
  </p:normalViewPr>
  <p:slideViewPr>
    <p:cSldViewPr>
      <p:cViewPr varScale="1">
        <p:scale>
          <a:sx n="101" d="100"/>
          <a:sy n="101" d="100"/>
        </p:scale>
        <p:origin x="132" y="1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theme" Target="theme/theme1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microsoft.com/office/2016/11/relationships/changesInfo" Target="changesInfos/changesInfo1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 Benaiges Boix" userId="521e2369-e457-46a3-9c7c-cd362f591386" providerId="ADAL" clId="{8F7DCFC5-4A2F-49F8-AF1A-A5250CB0FB0B}"/>
    <pc:docChg chg="undo custSel addSld delSld modSld sldOrd">
      <pc:chgData name="David Benaiges Boix" userId="521e2369-e457-46a3-9c7c-cd362f591386" providerId="ADAL" clId="{8F7DCFC5-4A2F-49F8-AF1A-A5250CB0FB0B}" dt="2023-04-21T07:41:31.570" v="175" actId="20577"/>
      <pc:docMkLst>
        <pc:docMk/>
      </pc:docMkLst>
      <pc:sldChg chg="addSp delSp modSp mod">
        <pc:chgData name="David Benaiges Boix" userId="521e2369-e457-46a3-9c7c-cd362f591386" providerId="ADAL" clId="{8F7DCFC5-4A2F-49F8-AF1A-A5250CB0FB0B}" dt="2023-04-21T07:31:10.257" v="86" actId="14100"/>
        <pc:sldMkLst>
          <pc:docMk/>
          <pc:sldMk cId="9675803" sldId="257"/>
        </pc:sldMkLst>
        <pc:picChg chg="add del mod">
          <ac:chgData name="David Benaiges Boix" userId="521e2369-e457-46a3-9c7c-cd362f591386" providerId="ADAL" clId="{8F7DCFC5-4A2F-49F8-AF1A-A5250CB0FB0B}" dt="2023-04-21T07:31:07.277" v="85" actId="478"/>
          <ac:picMkLst>
            <pc:docMk/>
            <pc:sldMk cId="9675803" sldId="257"/>
            <ac:picMk id="4" creationId="{A02D1203-6F47-2522-AF88-FF90F79E5B7A}"/>
          </ac:picMkLst>
        </pc:picChg>
        <pc:picChg chg="mod">
          <ac:chgData name="David Benaiges Boix" userId="521e2369-e457-46a3-9c7c-cd362f591386" providerId="ADAL" clId="{8F7DCFC5-4A2F-49F8-AF1A-A5250CB0FB0B}" dt="2023-04-21T07:31:10.257" v="86" actId="14100"/>
          <ac:picMkLst>
            <pc:docMk/>
            <pc:sldMk cId="9675803" sldId="257"/>
            <ac:picMk id="5" creationId="{00000000-0000-0000-0000-000000000000}"/>
          </ac:picMkLst>
        </pc:picChg>
      </pc:sldChg>
      <pc:sldChg chg="addSp delSp modSp mod">
        <pc:chgData name="David Benaiges Boix" userId="521e2369-e457-46a3-9c7c-cd362f591386" providerId="ADAL" clId="{8F7DCFC5-4A2F-49F8-AF1A-A5250CB0FB0B}" dt="2023-04-21T07:31:28.113" v="93" actId="14100"/>
        <pc:sldMkLst>
          <pc:docMk/>
          <pc:sldMk cId="3755910902" sldId="258"/>
        </pc:sldMkLst>
        <pc:picChg chg="add del mod">
          <ac:chgData name="David Benaiges Boix" userId="521e2369-e457-46a3-9c7c-cd362f591386" providerId="ADAL" clId="{8F7DCFC5-4A2F-49F8-AF1A-A5250CB0FB0B}" dt="2023-04-21T07:31:24.765" v="91" actId="478"/>
          <ac:picMkLst>
            <pc:docMk/>
            <pc:sldMk cId="3755910902" sldId="258"/>
            <ac:picMk id="4" creationId="{933FD9F4-0618-7EBF-8537-50CACC6AE044}"/>
          </ac:picMkLst>
        </pc:picChg>
        <pc:picChg chg="mod">
          <ac:chgData name="David Benaiges Boix" userId="521e2369-e457-46a3-9c7c-cd362f591386" providerId="ADAL" clId="{8F7DCFC5-4A2F-49F8-AF1A-A5250CB0FB0B}" dt="2023-04-21T07:31:28.113" v="93" actId="14100"/>
          <ac:picMkLst>
            <pc:docMk/>
            <pc:sldMk cId="3755910902" sldId="258"/>
            <ac:picMk id="5" creationId="{00000000-0000-0000-0000-000000000000}"/>
          </ac:picMkLst>
        </pc:picChg>
      </pc:sldChg>
      <pc:sldChg chg="addSp delSp modSp mod">
        <pc:chgData name="David Benaiges Boix" userId="521e2369-e457-46a3-9c7c-cd362f591386" providerId="ADAL" clId="{8F7DCFC5-4A2F-49F8-AF1A-A5250CB0FB0B}" dt="2023-04-21T07:31:44.457" v="100" actId="1076"/>
        <pc:sldMkLst>
          <pc:docMk/>
          <pc:sldMk cId="1130897378" sldId="259"/>
        </pc:sldMkLst>
        <pc:picChg chg="mod">
          <ac:chgData name="David Benaiges Boix" userId="521e2369-e457-46a3-9c7c-cd362f591386" providerId="ADAL" clId="{8F7DCFC5-4A2F-49F8-AF1A-A5250CB0FB0B}" dt="2023-04-21T07:31:44.457" v="100" actId="1076"/>
          <ac:picMkLst>
            <pc:docMk/>
            <pc:sldMk cId="1130897378" sldId="259"/>
            <ac:picMk id="4" creationId="{00000000-0000-0000-0000-000000000000}"/>
          </ac:picMkLst>
        </pc:picChg>
        <pc:picChg chg="add del mod">
          <ac:chgData name="David Benaiges Boix" userId="521e2369-e457-46a3-9c7c-cd362f591386" providerId="ADAL" clId="{8F7DCFC5-4A2F-49F8-AF1A-A5250CB0FB0B}" dt="2023-04-21T07:31:41.478" v="98" actId="478"/>
          <ac:picMkLst>
            <pc:docMk/>
            <pc:sldMk cId="1130897378" sldId="259"/>
            <ac:picMk id="5" creationId="{442A533E-87AA-BE89-B287-54015A477445}"/>
          </ac:picMkLst>
        </pc:picChg>
      </pc:sldChg>
      <pc:sldChg chg="addSp modSp mod">
        <pc:chgData name="David Benaiges Boix" userId="521e2369-e457-46a3-9c7c-cd362f591386" providerId="ADAL" clId="{8F7DCFC5-4A2F-49F8-AF1A-A5250CB0FB0B}" dt="2023-04-21T07:07:03.697" v="26" actId="1076"/>
        <pc:sldMkLst>
          <pc:docMk/>
          <pc:sldMk cId="2701774240" sldId="260"/>
        </pc:sldMkLst>
        <pc:picChg chg="add mod">
          <ac:chgData name="David Benaiges Boix" userId="521e2369-e457-46a3-9c7c-cd362f591386" providerId="ADAL" clId="{8F7DCFC5-4A2F-49F8-AF1A-A5250CB0FB0B}" dt="2023-04-21T07:07:03.697" v="26" actId="1076"/>
          <ac:picMkLst>
            <pc:docMk/>
            <pc:sldMk cId="2701774240" sldId="260"/>
            <ac:picMk id="4" creationId="{CD5BBFA8-258D-3E3D-7FAF-C1CD75D7AE72}"/>
          </ac:picMkLst>
        </pc:picChg>
        <pc:picChg chg="mod">
          <ac:chgData name="David Benaiges Boix" userId="521e2369-e457-46a3-9c7c-cd362f591386" providerId="ADAL" clId="{8F7DCFC5-4A2F-49F8-AF1A-A5250CB0FB0B}" dt="2023-04-21T07:06:55.248" v="21" actId="1076"/>
          <ac:picMkLst>
            <pc:docMk/>
            <pc:sldMk cId="2701774240" sldId="260"/>
            <ac:picMk id="5" creationId="{00000000-0000-0000-0000-000000000000}"/>
          </ac:picMkLst>
        </pc:picChg>
      </pc:sldChg>
      <pc:sldChg chg="addSp modSp mod">
        <pc:chgData name="David Benaiges Boix" userId="521e2369-e457-46a3-9c7c-cd362f591386" providerId="ADAL" clId="{8F7DCFC5-4A2F-49F8-AF1A-A5250CB0FB0B}" dt="2023-04-21T07:16:54.907" v="39" actId="1076"/>
        <pc:sldMkLst>
          <pc:docMk/>
          <pc:sldMk cId="2879922341" sldId="261"/>
        </pc:sldMkLst>
        <pc:picChg chg="mod">
          <ac:chgData name="David Benaiges Boix" userId="521e2369-e457-46a3-9c7c-cd362f591386" providerId="ADAL" clId="{8F7DCFC5-4A2F-49F8-AF1A-A5250CB0FB0B}" dt="2023-04-21T07:16:49.352" v="35" actId="1076"/>
          <ac:picMkLst>
            <pc:docMk/>
            <pc:sldMk cId="2879922341" sldId="261"/>
            <ac:picMk id="4" creationId="{00000000-0000-0000-0000-000000000000}"/>
          </ac:picMkLst>
        </pc:picChg>
        <pc:picChg chg="add mod">
          <ac:chgData name="David Benaiges Boix" userId="521e2369-e457-46a3-9c7c-cd362f591386" providerId="ADAL" clId="{8F7DCFC5-4A2F-49F8-AF1A-A5250CB0FB0B}" dt="2023-04-21T07:16:54.907" v="39" actId="1076"/>
          <ac:picMkLst>
            <pc:docMk/>
            <pc:sldMk cId="2879922341" sldId="261"/>
            <ac:picMk id="5" creationId="{43626224-3459-F803-BDC6-E502CE31EB79}"/>
          </ac:picMkLst>
        </pc:picChg>
      </pc:sldChg>
      <pc:sldChg chg="addSp delSp modSp mod">
        <pc:chgData name="David Benaiges Boix" userId="521e2369-e457-46a3-9c7c-cd362f591386" providerId="ADAL" clId="{8F7DCFC5-4A2F-49F8-AF1A-A5250CB0FB0B}" dt="2023-04-21T07:19:02.904" v="49" actId="1076"/>
        <pc:sldMkLst>
          <pc:docMk/>
          <pc:sldMk cId="44875863" sldId="262"/>
        </pc:sldMkLst>
        <pc:spChg chg="del">
          <ac:chgData name="David Benaiges Boix" userId="521e2369-e457-46a3-9c7c-cd362f591386" providerId="ADAL" clId="{8F7DCFC5-4A2F-49F8-AF1A-A5250CB0FB0B}" dt="2023-04-21T07:18:32.019" v="40" actId="478"/>
          <ac:spMkLst>
            <pc:docMk/>
            <pc:sldMk cId="44875863" sldId="262"/>
            <ac:spMk id="3" creationId="{00000000-0000-0000-0000-000000000000}"/>
          </ac:spMkLst>
        </pc:spChg>
        <pc:picChg chg="mod">
          <ac:chgData name="David Benaiges Boix" userId="521e2369-e457-46a3-9c7c-cd362f591386" providerId="ADAL" clId="{8F7DCFC5-4A2F-49F8-AF1A-A5250CB0FB0B}" dt="2023-04-21T07:18:36.369" v="43" actId="1076"/>
          <ac:picMkLst>
            <pc:docMk/>
            <pc:sldMk cId="44875863" sldId="262"/>
            <ac:picMk id="5" creationId="{00000000-0000-0000-0000-000000000000}"/>
          </ac:picMkLst>
        </pc:picChg>
        <pc:picChg chg="add del">
          <ac:chgData name="David Benaiges Boix" userId="521e2369-e457-46a3-9c7c-cd362f591386" providerId="ADAL" clId="{8F7DCFC5-4A2F-49F8-AF1A-A5250CB0FB0B}" dt="2023-04-21T07:18:55.324" v="45" actId="22"/>
          <ac:picMkLst>
            <pc:docMk/>
            <pc:sldMk cId="44875863" sldId="262"/>
            <ac:picMk id="6" creationId="{23101F7C-C921-3EF3-E538-E2FB5E4093B0}"/>
          </ac:picMkLst>
        </pc:picChg>
        <pc:picChg chg="add mod">
          <ac:chgData name="David Benaiges Boix" userId="521e2369-e457-46a3-9c7c-cd362f591386" providerId="ADAL" clId="{8F7DCFC5-4A2F-49F8-AF1A-A5250CB0FB0B}" dt="2023-04-21T07:19:02.904" v="49" actId="1076"/>
          <ac:picMkLst>
            <pc:docMk/>
            <pc:sldMk cId="44875863" sldId="262"/>
            <ac:picMk id="8" creationId="{F2DAA007-4AD0-4D1D-3069-3CBB6AC7D042}"/>
          </ac:picMkLst>
        </pc:picChg>
      </pc:sldChg>
      <pc:sldChg chg="addSp delSp modSp mod">
        <pc:chgData name="David Benaiges Boix" userId="521e2369-e457-46a3-9c7c-cd362f591386" providerId="ADAL" clId="{8F7DCFC5-4A2F-49F8-AF1A-A5250CB0FB0B}" dt="2023-04-21T07:20:39.945" v="58" actId="14100"/>
        <pc:sldMkLst>
          <pc:docMk/>
          <pc:sldMk cId="3053402920" sldId="263"/>
        </pc:sldMkLst>
        <pc:spChg chg="del">
          <ac:chgData name="David Benaiges Boix" userId="521e2369-e457-46a3-9c7c-cd362f591386" providerId="ADAL" clId="{8F7DCFC5-4A2F-49F8-AF1A-A5250CB0FB0B}" dt="2023-04-21T07:19:12.946" v="52" actId="478"/>
          <ac:spMkLst>
            <pc:docMk/>
            <pc:sldMk cId="3053402920" sldId="263"/>
            <ac:spMk id="3" creationId="{00000000-0000-0000-0000-000000000000}"/>
          </ac:spMkLst>
        </pc:spChg>
        <pc:picChg chg="mod">
          <ac:chgData name="David Benaiges Boix" userId="521e2369-e457-46a3-9c7c-cd362f591386" providerId="ADAL" clId="{8F7DCFC5-4A2F-49F8-AF1A-A5250CB0FB0B}" dt="2023-04-21T07:19:16.025" v="54" actId="1076"/>
          <ac:picMkLst>
            <pc:docMk/>
            <pc:sldMk cId="3053402920" sldId="263"/>
            <ac:picMk id="4" creationId="{00000000-0000-0000-0000-000000000000}"/>
          </ac:picMkLst>
        </pc:picChg>
        <pc:picChg chg="add mod">
          <ac:chgData name="David Benaiges Boix" userId="521e2369-e457-46a3-9c7c-cd362f591386" providerId="ADAL" clId="{8F7DCFC5-4A2F-49F8-AF1A-A5250CB0FB0B}" dt="2023-04-21T07:20:39.945" v="58" actId="14100"/>
          <ac:picMkLst>
            <pc:docMk/>
            <pc:sldMk cId="3053402920" sldId="263"/>
            <ac:picMk id="6" creationId="{2C6E0457-1548-47B7-7784-E1B6F33FA567}"/>
          </ac:picMkLst>
        </pc:picChg>
      </pc:sldChg>
      <pc:sldChg chg="addSp modSp mod">
        <pc:chgData name="David Benaiges Boix" userId="521e2369-e457-46a3-9c7c-cd362f591386" providerId="ADAL" clId="{8F7DCFC5-4A2F-49F8-AF1A-A5250CB0FB0B}" dt="2023-04-21T07:21:02.344" v="65" actId="1076"/>
        <pc:sldMkLst>
          <pc:docMk/>
          <pc:sldMk cId="3564102783" sldId="264"/>
        </pc:sldMkLst>
        <pc:picChg chg="mod">
          <ac:chgData name="David Benaiges Boix" userId="521e2369-e457-46a3-9c7c-cd362f591386" providerId="ADAL" clId="{8F7DCFC5-4A2F-49F8-AF1A-A5250CB0FB0B}" dt="2023-04-21T07:20:55.233" v="60" actId="1076"/>
          <ac:picMkLst>
            <pc:docMk/>
            <pc:sldMk cId="3564102783" sldId="264"/>
            <ac:picMk id="4" creationId="{00000000-0000-0000-0000-000000000000}"/>
          </ac:picMkLst>
        </pc:picChg>
        <pc:picChg chg="add mod">
          <ac:chgData name="David Benaiges Boix" userId="521e2369-e457-46a3-9c7c-cd362f591386" providerId="ADAL" clId="{8F7DCFC5-4A2F-49F8-AF1A-A5250CB0FB0B}" dt="2023-04-21T07:21:02.344" v="65" actId="1076"/>
          <ac:picMkLst>
            <pc:docMk/>
            <pc:sldMk cId="3564102783" sldId="264"/>
            <ac:picMk id="6" creationId="{92D7E7B6-8674-FF2F-DA01-25533D2A5B99}"/>
          </ac:picMkLst>
        </pc:picChg>
      </pc:sldChg>
      <pc:sldChg chg="addSp modSp mod">
        <pc:chgData name="David Benaiges Boix" userId="521e2369-e457-46a3-9c7c-cd362f591386" providerId="ADAL" clId="{8F7DCFC5-4A2F-49F8-AF1A-A5250CB0FB0B}" dt="2023-04-21T07:21:28.392" v="70" actId="1076"/>
        <pc:sldMkLst>
          <pc:docMk/>
          <pc:sldMk cId="1316722316" sldId="265"/>
        </pc:sldMkLst>
        <pc:picChg chg="mod">
          <ac:chgData name="David Benaiges Boix" userId="521e2369-e457-46a3-9c7c-cd362f591386" providerId="ADAL" clId="{8F7DCFC5-4A2F-49F8-AF1A-A5250CB0FB0B}" dt="2023-04-21T07:21:08.201" v="67" actId="1076"/>
          <ac:picMkLst>
            <pc:docMk/>
            <pc:sldMk cId="1316722316" sldId="265"/>
            <ac:picMk id="4" creationId="{00000000-0000-0000-0000-000000000000}"/>
          </ac:picMkLst>
        </pc:picChg>
        <pc:picChg chg="add mod">
          <ac:chgData name="David Benaiges Boix" userId="521e2369-e457-46a3-9c7c-cd362f591386" providerId="ADAL" clId="{8F7DCFC5-4A2F-49F8-AF1A-A5250CB0FB0B}" dt="2023-04-21T07:21:28.392" v="70" actId="1076"/>
          <ac:picMkLst>
            <pc:docMk/>
            <pc:sldMk cId="1316722316" sldId="265"/>
            <ac:picMk id="5" creationId="{3954DF76-06FD-0FE0-1409-D4BE63571B83}"/>
          </ac:picMkLst>
        </pc:picChg>
      </pc:sldChg>
      <pc:sldChg chg="addSp modSp mod">
        <pc:chgData name="David Benaiges Boix" userId="521e2369-e457-46a3-9c7c-cd362f591386" providerId="ADAL" clId="{8F7DCFC5-4A2F-49F8-AF1A-A5250CB0FB0B}" dt="2023-04-21T07:21:50.617" v="76" actId="1076"/>
        <pc:sldMkLst>
          <pc:docMk/>
          <pc:sldMk cId="1706186585" sldId="266"/>
        </pc:sldMkLst>
        <pc:picChg chg="mod">
          <ac:chgData name="David Benaiges Boix" userId="521e2369-e457-46a3-9c7c-cd362f591386" providerId="ADAL" clId="{8F7DCFC5-4A2F-49F8-AF1A-A5250CB0FB0B}" dt="2023-04-21T07:21:45.945" v="72" actId="1076"/>
          <ac:picMkLst>
            <pc:docMk/>
            <pc:sldMk cId="1706186585" sldId="266"/>
            <ac:picMk id="4" creationId="{00000000-0000-0000-0000-000000000000}"/>
          </ac:picMkLst>
        </pc:picChg>
        <pc:picChg chg="add mod">
          <ac:chgData name="David Benaiges Boix" userId="521e2369-e457-46a3-9c7c-cd362f591386" providerId="ADAL" clId="{8F7DCFC5-4A2F-49F8-AF1A-A5250CB0FB0B}" dt="2023-04-21T07:21:50.617" v="76" actId="1076"/>
          <ac:picMkLst>
            <pc:docMk/>
            <pc:sldMk cId="1706186585" sldId="266"/>
            <ac:picMk id="6" creationId="{47847196-8E84-AE94-56A1-7131FA129BDF}"/>
          </ac:picMkLst>
        </pc:picChg>
      </pc:sldChg>
      <pc:sldChg chg="addSp modSp mod">
        <pc:chgData name="David Benaiges Boix" userId="521e2369-e457-46a3-9c7c-cd362f591386" providerId="ADAL" clId="{8F7DCFC5-4A2F-49F8-AF1A-A5250CB0FB0B}" dt="2023-04-21T07:22:11.217" v="80" actId="1076"/>
        <pc:sldMkLst>
          <pc:docMk/>
          <pc:sldMk cId="2168380748" sldId="267"/>
        </pc:sldMkLst>
        <pc:picChg chg="mod">
          <ac:chgData name="David Benaiges Boix" userId="521e2369-e457-46a3-9c7c-cd362f591386" providerId="ADAL" clId="{8F7DCFC5-4A2F-49F8-AF1A-A5250CB0FB0B}" dt="2023-04-21T07:22:06.072" v="77" actId="1076"/>
          <ac:picMkLst>
            <pc:docMk/>
            <pc:sldMk cId="2168380748" sldId="267"/>
            <ac:picMk id="4" creationId="{00000000-0000-0000-0000-000000000000}"/>
          </ac:picMkLst>
        </pc:picChg>
        <pc:picChg chg="add mod">
          <ac:chgData name="David Benaiges Boix" userId="521e2369-e457-46a3-9c7c-cd362f591386" providerId="ADAL" clId="{8F7DCFC5-4A2F-49F8-AF1A-A5250CB0FB0B}" dt="2023-04-21T07:22:11.217" v="80" actId="1076"/>
          <ac:picMkLst>
            <pc:docMk/>
            <pc:sldMk cId="2168380748" sldId="267"/>
            <ac:picMk id="6" creationId="{CA16C264-6E6F-FAEE-CE00-EFA00C027818}"/>
          </ac:picMkLst>
        </pc:picChg>
      </pc:sldChg>
      <pc:sldChg chg="addSp delSp modSp new mod ord">
        <pc:chgData name="David Benaiges Boix" userId="521e2369-e457-46a3-9c7c-cd362f591386" providerId="ADAL" clId="{8F7DCFC5-4A2F-49F8-AF1A-A5250CB0FB0B}" dt="2023-04-21T07:05:51.796" v="12"/>
        <pc:sldMkLst>
          <pc:docMk/>
          <pc:sldMk cId="3554804312" sldId="268"/>
        </pc:sldMkLst>
        <pc:spChg chg="add del">
          <ac:chgData name="David Benaiges Boix" userId="521e2369-e457-46a3-9c7c-cd362f591386" providerId="ADAL" clId="{8F7DCFC5-4A2F-49F8-AF1A-A5250CB0FB0B}" dt="2023-04-21T07:05:49.516" v="11" actId="3680"/>
          <ac:spMkLst>
            <pc:docMk/>
            <pc:sldMk cId="3554804312" sldId="268"/>
            <ac:spMk id="3" creationId="{32609807-2023-A8B0-DE49-B99BBDAF0E05}"/>
          </ac:spMkLst>
        </pc:spChg>
        <pc:graphicFrameChg chg="add del mod ord modGraphic">
          <ac:chgData name="David Benaiges Boix" userId="521e2369-e457-46a3-9c7c-cd362f591386" providerId="ADAL" clId="{8F7DCFC5-4A2F-49F8-AF1A-A5250CB0FB0B}" dt="2023-04-21T07:05:43.152" v="10" actId="3680"/>
          <ac:graphicFrameMkLst>
            <pc:docMk/>
            <pc:sldMk cId="3554804312" sldId="268"/>
            <ac:graphicFrameMk id="4" creationId="{1CCFA007-095A-BE22-AD1C-9F8B99BE3690}"/>
          </ac:graphicFrameMkLst>
        </pc:graphicFrameChg>
        <pc:graphicFrameChg chg="add mod ord modGraphic">
          <ac:chgData name="David Benaiges Boix" userId="521e2369-e457-46a3-9c7c-cd362f591386" providerId="ADAL" clId="{8F7DCFC5-4A2F-49F8-AF1A-A5250CB0FB0B}" dt="2023-04-21T07:05:51.796" v="12"/>
          <ac:graphicFrameMkLst>
            <pc:docMk/>
            <pc:sldMk cId="3554804312" sldId="268"/>
            <ac:graphicFrameMk id="5" creationId="{FB2A55C1-C151-386A-7CE5-47E0AC5ED199}"/>
          </ac:graphicFrameMkLst>
        </pc:graphicFrameChg>
      </pc:sldChg>
      <pc:sldChg chg="new del">
        <pc:chgData name="David Benaiges Boix" userId="521e2369-e457-46a3-9c7c-cd362f591386" providerId="ADAL" clId="{8F7DCFC5-4A2F-49F8-AF1A-A5250CB0FB0B}" dt="2023-04-21T07:31:00.138" v="83" actId="47"/>
        <pc:sldMkLst>
          <pc:docMk/>
          <pc:sldMk cId="3084140420" sldId="269"/>
        </pc:sldMkLst>
      </pc:sldChg>
      <pc:sldChg chg="addSp delSp modSp add mod">
        <pc:chgData name="David Benaiges Boix" userId="521e2369-e457-46a3-9c7c-cd362f591386" providerId="ADAL" clId="{8F7DCFC5-4A2F-49F8-AF1A-A5250CB0FB0B}" dt="2023-04-21T07:41:31.570" v="175" actId="20577"/>
        <pc:sldMkLst>
          <pc:docMk/>
          <pc:sldMk cId="3633168833" sldId="269"/>
        </pc:sldMkLst>
        <pc:spChg chg="add mod">
          <ac:chgData name="David Benaiges Boix" userId="521e2369-e457-46a3-9c7c-cd362f591386" providerId="ADAL" clId="{8F7DCFC5-4A2F-49F8-AF1A-A5250CB0FB0B}" dt="2023-04-21T07:41:31.570" v="175" actId="20577"/>
          <ac:spMkLst>
            <pc:docMk/>
            <pc:sldMk cId="3633168833" sldId="269"/>
            <ac:spMk id="6" creationId="{EE38BB84-1095-A12C-E1C4-C273EE07ED11}"/>
          </ac:spMkLst>
        </pc:spChg>
        <pc:graphicFrameChg chg="add del">
          <ac:chgData name="David Benaiges Boix" userId="521e2369-e457-46a3-9c7c-cd362f591386" providerId="ADAL" clId="{8F7DCFC5-4A2F-49F8-AF1A-A5250CB0FB0B}" dt="2023-04-21T07:39:29.568" v="162" actId="478"/>
          <ac:graphicFrameMkLst>
            <pc:docMk/>
            <pc:sldMk cId="3633168833" sldId="269"/>
            <ac:graphicFrameMk id="3" creationId="{C359CAA5-43D4-049C-2A5E-46E155C09643}"/>
          </ac:graphicFrameMkLst>
        </pc:graphicFrameChg>
        <pc:picChg chg="mod">
          <ac:chgData name="David Benaiges Boix" userId="521e2369-e457-46a3-9c7c-cd362f591386" providerId="ADAL" clId="{8F7DCFC5-4A2F-49F8-AF1A-A5250CB0FB0B}" dt="2023-04-21T07:31:16.769" v="89" actId="14100"/>
          <ac:picMkLst>
            <pc:docMk/>
            <pc:sldMk cId="3633168833" sldId="269"/>
            <ac:picMk id="4" creationId="{A02D1203-6F47-2522-AF88-FF90F79E5B7A}"/>
          </ac:picMkLst>
        </pc:picChg>
        <pc:picChg chg="del">
          <ac:chgData name="David Benaiges Boix" userId="521e2369-e457-46a3-9c7c-cd362f591386" providerId="ADAL" clId="{8F7DCFC5-4A2F-49F8-AF1A-A5250CB0FB0B}" dt="2023-04-21T07:31:12.290" v="87" actId="478"/>
          <ac:picMkLst>
            <pc:docMk/>
            <pc:sldMk cId="3633168833" sldId="269"/>
            <ac:picMk id="5" creationId="{00000000-0000-0000-0000-000000000000}"/>
          </ac:picMkLst>
        </pc:picChg>
      </pc:sldChg>
      <pc:sldChg chg="delSp modSp add mod">
        <pc:chgData name="David Benaiges Boix" userId="521e2369-e457-46a3-9c7c-cd362f591386" providerId="ADAL" clId="{8F7DCFC5-4A2F-49F8-AF1A-A5250CB0FB0B}" dt="2023-04-21T07:31:34.625" v="96" actId="14100"/>
        <pc:sldMkLst>
          <pc:docMk/>
          <pc:sldMk cId="3101199349" sldId="270"/>
        </pc:sldMkLst>
        <pc:picChg chg="mod">
          <ac:chgData name="David Benaiges Boix" userId="521e2369-e457-46a3-9c7c-cd362f591386" providerId="ADAL" clId="{8F7DCFC5-4A2F-49F8-AF1A-A5250CB0FB0B}" dt="2023-04-21T07:31:34.625" v="96" actId="14100"/>
          <ac:picMkLst>
            <pc:docMk/>
            <pc:sldMk cId="3101199349" sldId="270"/>
            <ac:picMk id="4" creationId="{933FD9F4-0618-7EBF-8537-50CACC6AE044}"/>
          </ac:picMkLst>
        </pc:picChg>
        <pc:picChg chg="del">
          <ac:chgData name="David Benaiges Boix" userId="521e2369-e457-46a3-9c7c-cd362f591386" providerId="ADAL" clId="{8F7DCFC5-4A2F-49F8-AF1A-A5250CB0FB0B}" dt="2023-04-21T07:31:30.828" v="94" actId="478"/>
          <ac:picMkLst>
            <pc:docMk/>
            <pc:sldMk cId="3101199349" sldId="270"/>
            <ac:picMk id="5" creationId="{00000000-0000-0000-0000-000000000000}"/>
          </ac:picMkLst>
        </pc:picChg>
      </pc:sldChg>
      <pc:sldChg chg="delSp modSp add mod">
        <pc:chgData name="David Benaiges Boix" userId="521e2369-e457-46a3-9c7c-cd362f591386" providerId="ADAL" clId="{8F7DCFC5-4A2F-49F8-AF1A-A5250CB0FB0B}" dt="2023-04-21T07:31:50.740" v="104" actId="1076"/>
        <pc:sldMkLst>
          <pc:docMk/>
          <pc:sldMk cId="2340882593" sldId="271"/>
        </pc:sldMkLst>
        <pc:picChg chg="del">
          <ac:chgData name="David Benaiges Boix" userId="521e2369-e457-46a3-9c7c-cd362f591386" providerId="ADAL" clId="{8F7DCFC5-4A2F-49F8-AF1A-A5250CB0FB0B}" dt="2023-04-21T07:31:46.548" v="101" actId="478"/>
          <ac:picMkLst>
            <pc:docMk/>
            <pc:sldMk cId="2340882593" sldId="271"/>
            <ac:picMk id="4" creationId="{00000000-0000-0000-0000-000000000000}"/>
          </ac:picMkLst>
        </pc:picChg>
        <pc:picChg chg="mod">
          <ac:chgData name="David Benaiges Boix" userId="521e2369-e457-46a3-9c7c-cd362f591386" providerId="ADAL" clId="{8F7DCFC5-4A2F-49F8-AF1A-A5250CB0FB0B}" dt="2023-04-21T07:31:50.740" v="104" actId="1076"/>
          <ac:picMkLst>
            <pc:docMk/>
            <pc:sldMk cId="2340882593" sldId="271"/>
            <ac:picMk id="5" creationId="{442A533E-87AA-BE89-B287-54015A477445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2E493-D7B9-4CA9-A79B-08A534E7E6EC}" type="datetimeFigureOut">
              <a:rPr lang="es-ES" smtClean="0"/>
              <a:t>17/03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9459A-2935-4518-9528-A2C4AFEB07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9352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2E493-D7B9-4CA9-A79B-08A534E7E6EC}" type="datetimeFigureOut">
              <a:rPr lang="es-ES" smtClean="0"/>
              <a:t>17/03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9459A-2935-4518-9528-A2C4AFEB07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8595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2E493-D7B9-4CA9-A79B-08A534E7E6EC}" type="datetimeFigureOut">
              <a:rPr lang="es-ES" smtClean="0"/>
              <a:t>17/03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9459A-2935-4518-9528-A2C4AFEB07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3886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2E493-D7B9-4CA9-A79B-08A534E7E6EC}" type="datetimeFigureOut">
              <a:rPr lang="es-ES" smtClean="0"/>
              <a:t>17/03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9459A-2935-4518-9528-A2C4AFEB07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6667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2E493-D7B9-4CA9-A79B-08A534E7E6EC}" type="datetimeFigureOut">
              <a:rPr lang="es-ES" smtClean="0"/>
              <a:t>17/03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9459A-2935-4518-9528-A2C4AFEB07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168550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2E493-D7B9-4CA9-A79B-08A534E7E6EC}" type="datetimeFigureOut">
              <a:rPr lang="es-ES" smtClean="0"/>
              <a:t>17/03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9459A-2935-4518-9528-A2C4AFEB07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2587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2E493-D7B9-4CA9-A79B-08A534E7E6EC}" type="datetimeFigureOut">
              <a:rPr lang="es-ES" smtClean="0"/>
              <a:t>17/03/2024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9459A-2935-4518-9528-A2C4AFEB07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5321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2E493-D7B9-4CA9-A79B-08A534E7E6EC}" type="datetimeFigureOut">
              <a:rPr lang="es-ES" smtClean="0"/>
              <a:t>17/03/2024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9459A-2935-4518-9528-A2C4AFEB07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8821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2E493-D7B9-4CA9-A79B-08A534E7E6EC}" type="datetimeFigureOut">
              <a:rPr lang="es-ES" smtClean="0"/>
              <a:t>17/03/2024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9459A-2935-4518-9528-A2C4AFEB07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2500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2E493-D7B9-4CA9-A79B-08A534E7E6EC}" type="datetimeFigureOut">
              <a:rPr lang="es-ES" smtClean="0"/>
              <a:t>17/03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9459A-2935-4518-9528-A2C4AFEB07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17818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2E493-D7B9-4CA9-A79B-08A534E7E6EC}" type="datetimeFigureOut">
              <a:rPr lang="es-ES" smtClean="0"/>
              <a:t>17/03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9459A-2935-4518-9528-A2C4AFEB07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4306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62E493-D7B9-4CA9-A79B-08A534E7E6EC}" type="datetimeFigureOut">
              <a:rPr lang="es-ES" smtClean="0"/>
              <a:t>17/03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9459A-2935-4518-9528-A2C4AFEB07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6644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0" y="116632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a: Forest plot showing the results of meta-analyses for LGA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2 Rectángulo"/>
          <p:cNvSpPr/>
          <p:nvPr/>
        </p:nvSpPr>
        <p:spPr>
          <a:xfrm>
            <a:off x="407368" y="6536377"/>
            <a:ext cx="21455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GA: large for gestational age </a:t>
            </a:r>
            <a:endParaRPr lang="es-ES" sz="1200" dirty="0"/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1424" y="836712"/>
            <a:ext cx="10297144" cy="50819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591090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1 Título"/>
          <p:cNvSpPr>
            <a:spLocks noGrp="1"/>
          </p:cNvSpPr>
          <p:nvPr>
            <p:ph type="title"/>
          </p:nvPr>
        </p:nvSpPr>
        <p:spPr>
          <a:xfrm>
            <a:off x="0" y="188640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b: funnel plot and </a:t>
            </a:r>
            <a:r>
              <a:rPr lang="en-US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's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gger's test assessing publication bias for preterm delivery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7824192" y="2924944"/>
            <a:ext cx="31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41</a:t>
            </a: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61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2784392" y="1142088"/>
            <a:ext cx="6840000" cy="4879200"/>
            <a:chOff x="2784392" y="1142088"/>
            <a:chExt cx="6840000" cy="4879200"/>
          </a:xfrm>
        </p:grpSpPr>
        <p:pic>
          <p:nvPicPr>
            <p:cNvPr id="5" name="Imatge 4">
              <a:extLst>
                <a:ext uri="{FF2B5EF4-FFF2-40B4-BE49-F238E27FC236}">
                  <a16:creationId xmlns:a16="http://schemas.microsoft.com/office/drawing/2014/main" id="{43626224-3459-F803-BDC6-E502CE31EB7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784392" y="1142088"/>
              <a:ext cx="6840000" cy="4879200"/>
            </a:xfrm>
            <a:prstGeom prst="rect">
              <a:avLst/>
            </a:prstGeom>
          </p:spPr>
        </p:pic>
        <p:pic>
          <p:nvPicPr>
            <p:cNvPr id="6" name="Imagen 5"/>
            <p:cNvPicPr>
              <a:picLocks noChangeAspect="1"/>
            </p:cNvPicPr>
            <p:nvPr/>
          </p:nvPicPr>
          <p:blipFill rotWithShape="1">
            <a:blip r:embed="rId3"/>
            <a:srcRect l="34250" t="75200" r="9051" b="17800"/>
            <a:stretch/>
          </p:blipFill>
          <p:spPr>
            <a:xfrm>
              <a:off x="2856334" y="5426518"/>
              <a:ext cx="6696050" cy="450754"/>
            </a:xfrm>
            <a:prstGeom prst="rect">
              <a:avLst/>
            </a:prstGeom>
          </p:spPr>
        </p:pic>
      </p:grpSp>
      <p:sp>
        <p:nvSpPr>
          <p:cNvPr id="9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7976592" y="3077344"/>
            <a:ext cx="31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41</a:t>
            </a: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61</a:t>
            </a:r>
          </a:p>
        </p:txBody>
      </p:sp>
    </p:spTree>
    <p:extLst>
      <p:ext uri="{BB962C8B-B14F-4D97-AF65-F5344CB8AC3E}">
        <p14:creationId xmlns:p14="http://schemas.microsoft.com/office/powerpoint/2010/main" val="393915043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1 Título"/>
          <p:cNvSpPr>
            <a:spLocks noGrp="1"/>
          </p:cNvSpPr>
          <p:nvPr>
            <p:ph type="title"/>
          </p:nvPr>
        </p:nvSpPr>
        <p:spPr>
          <a:xfrm>
            <a:off x="0" y="188640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a: Forest plot showing the results of meta-analyses for cesarean section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3392" y="836712"/>
            <a:ext cx="10513168" cy="51885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586947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1 Título"/>
          <p:cNvSpPr>
            <a:spLocks noGrp="1"/>
          </p:cNvSpPr>
          <p:nvPr>
            <p:ph type="title"/>
          </p:nvPr>
        </p:nvSpPr>
        <p:spPr>
          <a:xfrm>
            <a:off x="0" y="260648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b: funnel plot and </a:t>
            </a:r>
            <a:r>
              <a:rPr lang="en-US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's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gger's test assessing publication bias for cesarean section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6960096" y="3111351"/>
            <a:ext cx="31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937</a:t>
            </a: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84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2639616" y="1196752"/>
            <a:ext cx="6840000" cy="4879200"/>
            <a:chOff x="2639616" y="1196752"/>
            <a:chExt cx="6840000" cy="4879200"/>
          </a:xfrm>
        </p:grpSpPr>
        <p:pic>
          <p:nvPicPr>
            <p:cNvPr id="8" name="Imatge 7">
              <a:extLst>
                <a:ext uri="{FF2B5EF4-FFF2-40B4-BE49-F238E27FC236}">
                  <a16:creationId xmlns:a16="http://schemas.microsoft.com/office/drawing/2014/main" id="{F2DAA007-4AD0-4D1D-3069-3CBB6AC7D0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39616" y="1196752"/>
              <a:ext cx="6840000" cy="4879200"/>
            </a:xfrm>
            <a:prstGeom prst="rect">
              <a:avLst/>
            </a:prstGeom>
          </p:spPr>
        </p:pic>
        <p:pic>
          <p:nvPicPr>
            <p:cNvPr id="5" name="Imagen 4"/>
            <p:cNvPicPr>
              <a:picLocks noChangeAspect="1"/>
            </p:cNvPicPr>
            <p:nvPr/>
          </p:nvPicPr>
          <p:blipFill rotWithShape="1">
            <a:blip r:embed="rId3"/>
            <a:srcRect l="34250" t="75200" r="9051" b="17800"/>
            <a:stretch/>
          </p:blipFill>
          <p:spPr>
            <a:xfrm>
              <a:off x="2814189" y="5480347"/>
              <a:ext cx="6490854" cy="450754"/>
            </a:xfrm>
            <a:prstGeom prst="rect">
              <a:avLst/>
            </a:prstGeom>
          </p:spPr>
        </p:pic>
      </p:grpSp>
      <p:sp>
        <p:nvSpPr>
          <p:cNvPr id="9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7112496" y="3263751"/>
            <a:ext cx="31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937</a:t>
            </a: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84</a:t>
            </a:r>
          </a:p>
        </p:txBody>
      </p:sp>
    </p:spTree>
    <p:extLst>
      <p:ext uri="{BB962C8B-B14F-4D97-AF65-F5344CB8AC3E}">
        <p14:creationId xmlns:p14="http://schemas.microsoft.com/office/powerpoint/2010/main" val="200726434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1 Título"/>
          <p:cNvSpPr>
            <a:spLocks noGrp="1"/>
          </p:cNvSpPr>
          <p:nvPr>
            <p:ph type="title"/>
          </p:nvPr>
        </p:nvSpPr>
        <p:spPr>
          <a:xfrm>
            <a:off x="6018" y="260648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a: Forest plot showing the results of meta-analyses for labor induction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2494" y="1052736"/>
            <a:ext cx="11119048" cy="42484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340292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1 Título"/>
          <p:cNvSpPr>
            <a:spLocks noGrp="1"/>
          </p:cNvSpPr>
          <p:nvPr>
            <p:ph type="title"/>
          </p:nvPr>
        </p:nvSpPr>
        <p:spPr>
          <a:xfrm>
            <a:off x="0" y="332656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b: funnel plot and </a:t>
            </a:r>
            <a:r>
              <a:rPr lang="en-US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's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gger's test assessing publication bias for labor induction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7320136" y="3573016"/>
            <a:ext cx="31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12</a:t>
            </a: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42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2856400" y="1286104"/>
            <a:ext cx="6840000" cy="4879200"/>
            <a:chOff x="2856400" y="1286104"/>
            <a:chExt cx="6840000" cy="4879200"/>
          </a:xfrm>
        </p:grpSpPr>
        <p:pic>
          <p:nvPicPr>
            <p:cNvPr id="6" name="Imatge 5">
              <a:extLst>
                <a:ext uri="{FF2B5EF4-FFF2-40B4-BE49-F238E27FC236}">
                  <a16:creationId xmlns:a16="http://schemas.microsoft.com/office/drawing/2014/main" id="{2C6E0457-1548-47B7-7784-E1B6F33FA56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56400" y="1286104"/>
              <a:ext cx="6840000" cy="4879200"/>
            </a:xfrm>
            <a:prstGeom prst="rect">
              <a:avLst/>
            </a:prstGeom>
          </p:spPr>
        </p:pic>
        <p:pic>
          <p:nvPicPr>
            <p:cNvPr id="5" name="Imagen 4"/>
            <p:cNvPicPr>
              <a:picLocks noChangeAspect="1"/>
            </p:cNvPicPr>
            <p:nvPr/>
          </p:nvPicPr>
          <p:blipFill rotWithShape="1">
            <a:blip r:embed="rId3"/>
            <a:srcRect l="34250" t="75200" r="9051" b="17800"/>
            <a:stretch/>
          </p:blipFill>
          <p:spPr>
            <a:xfrm>
              <a:off x="3030973" y="5589240"/>
              <a:ext cx="6490854" cy="450754"/>
            </a:xfrm>
            <a:prstGeom prst="rect">
              <a:avLst/>
            </a:prstGeom>
          </p:spPr>
        </p:pic>
      </p:grpSp>
      <p:sp>
        <p:nvSpPr>
          <p:cNvPr id="9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7472536" y="3725416"/>
            <a:ext cx="31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12</a:t>
            </a: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42</a:t>
            </a:r>
          </a:p>
        </p:txBody>
      </p:sp>
    </p:spTree>
    <p:extLst>
      <p:ext uri="{BB962C8B-B14F-4D97-AF65-F5344CB8AC3E}">
        <p14:creationId xmlns:p14="http://schemas.microsoft.com/office/powerpoint/2010/main" val="16387912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tge 5">
            <a:extLst>
              <a:ext uri="{FF2B5EF4-FFF2-40B4-BE49-F238E27FC236}">
                <a16:creationId xmlns:a16="http://schemas.microsoft.com/office/drawing/2014/main" id="{92D7E7B6-8674-FF2F-DA01-25533D2A5B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87688" y="3429360"/>
            <a:ext cx="4859999" cy="3240000"/>
          </a:xfrm>
          <a:prstGeom prst="rect">
            <a:avLst/>
          </a:prstGeom>
        </p:spPr>
      </p:pic>
      <p:sp>
        <p:nvSpPr>
          <p:cNvPr id="7" name="1 Título"/>
          <p:cNvSpPr>
            <a:spLocks noGrp="1"/>
          </p:cNvSpPr>
          <p:nvPr>
            <p:ph type="title"/>
          </p:nvPr>
        </p:nvSpPr>
        <p:spPr>
          <a:xfrm>
            <a:off x="6018" y="-27384"/>
            <a:ext cx="12192000" cy="576064"/>
          </a:xfrm>
        </p:spPr>
        <p:txBody>
          <a:bodyPr>
            <a:norm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a: Forest plot showing the results of meta-analyses for major congenital anomalies</a:t>
            </a:r>
            <a:endParaRPr lang="es-E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24680" y="2708920"/>
            <a:ext cx="12192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8b: funnel plot and </a:t>
            </a:r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's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gger's test assessing publication bias for major congenital anomalies</a:t>
            </a:r>
            <a:endParaRPr lang="es-E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6888088" y="5013176"/>
            <a:ext cx="31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951</a:t>
            </a: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02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3761" y="611906"/>
            <a:ext cx="10216631" cy="18089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410278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tge 4">
            <a:extLst>
              <a:ext uri="{FF2B5EF4-FFF2-40B4-BE49-F238E27FC236}">
                <a16:creationId xmlns:a16="http://schemas.microsoft.com/office/drawing/2014/main" id="{3954DF76-06FD-0FE0-1409-D4BE63571B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92264" y="3621368"/>
            <a:ext cx="4680000" cy="3120000"/>
          </a:xfrm>
          <a:prstGeom prst="rect">
            <a:avLst/>
          </a:prstGeom>
        </p:spPr>
      </p:pic>
      <p:sp>
        <p:nvSpPr>
          <p:cNvPr id="6" name="1 Título"/>
          <p:cNvSpPr>
            <a:spLocks noGrp="1"/>
          </p:cNvSpPr>
          <p:nvPr>
            <p:ph type="title"/>
          </p:nvPr>
        </p:nvSpPr>
        <p:spPr>
          <a:xfrm>
            <a:off x="6018" y="-27384"/>
            <a:ext cx="12192000" cy="576064"/>
          </a:xfrm>
        </p:spPr>
        <p:txBody>
          <a:bodyPr>
            <a:norm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a: Forest plot showing the results of meta-analyses for perinatal death</a:t>
            </a:r>
            <a:endParaRPr lang="es-E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1 Título"/>
          <p:cNvSpPr txBox="1">
            <a:spLocks/>
          </p:cNvSpPr>
          <p:nvPr/>
        </p:nvSpPr>
        <p:spPr>
          <a:xfrm>
            <a:off x="24680" y="2924944"/>
            <a:ext cx="12192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9b: funnel plot and </a:t>
            </a:r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's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gger's test assessing publication bias for perinatal death</a:t>
            </a:r>
            <a:endParaRPr lang="es-E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7536160" y="5013176"/>
            <a:ext cx="31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583</a:t>
            </a: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02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392" y="548680"/>
            <a:ext cx="10759468" cy="19442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672231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tge 5">
            <a:extLst>
              <a:ext uri="{FF2B5EF4-FFF2-40B4-BE49-F238E27FC236}">
                <a16:creationId xmlns:a16="http://schemas.microsoft.com/office/drawing/2014/main" id="{47847196-8E84-AE94-56A1-7131FA129B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4271" y="3573376"/>
            <a:ext cx="4860001" cy="3240000"/>
          </a:xfrm>
          <a:prstGeom prst="rect">
            <a:avLst/>
          </a:prstGeom>
        </p:spPr>
      </p:pic>
      <p:sp>
        <p:nvSpPr>
          <p:cNvPr id="7" name="1 Título"/>
          <p:cNvSpPr>
            <a:spLocks noGrp="1"/>
          </p:cNvSpPr>
          <p:nvPr>
            <p:ph type="title"/>
          </p:nvPr>
        </p:nvSpPr>
        <p:spPr>
          <a:xfrm>
            <a:off x="6018" y="-27384"/>
            <a:ext cx="12192000" cy="576064"/>
          </a:xfrm>
        </p:spPr>
        <p:txBody>
          <a:bodyPr>
            <a:norm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a: Forest plot showing the results of meta-analyses for hyperbilirubinemia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24680" y="2924944"/>
            <a:ext cx="12192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0b: funnel plot and </a:t>
            </a:r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's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gger's test assessing publication bias for hyperbilirubinemia</a:t>
            </a:r>
            <a:endParaRPr lang="es-E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7286533" y="4869160"/>
            <a:ext cx="31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57</a:t>
            </a: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24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1423" y="548680"/>
            <a:ext cx="10115739" cy="2160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618658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9415" y="620688"/>
            <a:ext cx="10080000" cy="1627447"/>
          </a:xfrm>
          <a:prstGeom prst="rect">
            <a:avLst/>
          </a:prstGeom>
        </p:spPr>
      </p:pic>
      <p:pic>
        <p:nvPicPr>
          <p:cNvPr id="6" name="Imatge 5">
            <a:extLst>
              <a:ext uri="{FF2B5EF4-FFF2-40B4-BE49-F238E27FC236}">
                <a16:creationId xmlns:a16="http://schemas.microsoft.com/office/drawing/2014/main" id="{CA16C264-6E6F-FAEE-CE00-EFA00C0278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5720" y="3549361"/>
            <a:ext cx="4680000" cy="3119999"/>
          </a:xfrm>
          <a:prstGeom prst="rect">
            <a:avLst/>
          </a:prstGeom>
        </p:spPr>
      </p:pic>
      <p:sp>
        <p:nvSpPr>
          <p:cNvPr id="7" name="1 Título"/>
          <p:cNvSpPr>
            <a:spLocks noGrp="1"/>
          </p:cNvSpPr>
          <p:nvPr>
            <p:ph type="title"/>
          </p:nvPr>
        </p:nvSpPr>
        <p:spPr>
          <a:xfrm>
            <a:off x="6018" y="-27384"/>
            <a:ext cx="12192000" cy="576064"/>
          </a:xfrm>
        </p:spPr>
        <p:txBody>
          <a:bodyPr>
            <a:norm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1a: Forest plot showing the results of meta-analyses for fetal respiratory distress</a:t>
            </a:r>
          </a:p>
        </p:txBody>
      </p:sp>
      <p:sp>
        <p:nvSpPr>
          <p:cNvPr id="8" name="1 Título"/>
          <p:cNvSpPr txBox="1">
            <a:spLocks/>
          </p:cNvSpPr>
          <p:nvPr/>
        </p:nvSpPr>
        <p:spPr>
          <a:xfrm>
            <a:off x="24680" y="2780928"/>
            <a:ext cx="12192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1b: funnel plot and </a:t>
            </a:r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's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gger's test assessing publication bias for fetal respiratory distress</a:t>
            </a:r>
            <a:endParaRPr lang="es-E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7286533" y="4869160"/>
            <a:ext cx="3168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17</a:t>
            </a:r>
          </a:p>
        </p:txBody>
      </p:sp>
    </p:spTree>
    <p:extLst>
      <p:ext uri="{BB962C8B-B14F-4D97-AF65-F5344CB8AC3E}">
        <p14:creationId xmlns:p14="http://schemas.microsoft.com/office/powerpoint/2010/main" val="216838074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ula 5">
            <a:extLst>
              <a:ext uri="{FF2B5EF4-FFF2-40B4-BE49-F238E27FC236}">
                <a16:creationId xmlns:a16="http://schemas.microsoft.com/office/drawing/2014/main" id="{FB2A55C1-C151-386A-7CE5-47E0AC5ED19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537173821"/>
              </p:ext>
            </p:extLst>
          </p:nvPr>
        </p:nvGraphicFramePr>
        <p:xfrm>
          <a:off x="335360" y="620688"/>
          <a:ext cx="10801200" cy="561662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00400">
                  <a:extLst>
                    <a:ext uri="{9D8B030D-6E8A-4147-A177-3AD203B41FA5}">
                      <a16:colId xmlns:a16="http://schemas.microsoft.com/office/drawing/2014/main" val="2393646410"/>
                    </a:ext>
                  </a:extLst>
                </a:gridCol>
                <a:gridCol w="3600400">
                  <a:extLst>
                    <a:ext uri="{9D8B030D-6E8A-4147-A177-3AD203B41FA5}">
                      <a16:colId xmlns:a16="http://schemas.microsoft.com/office/drawing/2014/main" val="2182375212"/>
                    </a:ext>
                  </a:extLst>
                </a:gridCol>
                <a:gridCol w="3600400">
                  <a:extLst>
                    <a:ext uri="{9D8B030D-6E8A-4147-A177-3AD203B41FA5}">
                      <a16:colId xmlns:a16="http://schemas.microsoft.com/office/drawing/2014/main" val="4135010009"/>
                    </a:ext>
                  </a:extLst>
                </a:gridCol>
              </a:tblGrid>
              <a:tr h="468052"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endParaRPr lang="ca-ES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GGE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G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4682854"/>
                  </a:ext>
                </a:extLst>
              </a:tr>
              <a:tr h="468052">
                <a:tc>
                  <a:txBody>
                    <a:bodyPr/>
                    <a:lstStyle/>
                    <a:p>
                      <a:pPr marL="0" indent="0" algn="l" fontAlgn="b">
                        <a:lnSpc>
                          <a:spcPct val="15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en-US" sz="2000" b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Macrosomia</a:t>
                      </a:r>
                      <a:endParaRPr lang="ca-E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9221706"/>
                  </a:ext>
                </a:extLst>
              </a:tr>
              <a:tr h="468052">
                <a:tc>
                  <a:txBody>
                    <a:bodyPr/>
                    <a:lstStyle/>
                    <a:p>
                      <a:pPr marL="0" indent="0" algn="l" fontAlgn="b">
                        <a:lnSpc>
                          <a:spcPct val="15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ca-E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G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4146106"/>
                  </a:ext>
                </a:extLst>
              </a:tr>
              <a:tr h="468052">
                <a:tc>
                  <a:txBody>
                    <a:bodyPr/>
                    <a:lstStyle/>
                    <a:p>
                      <a:pPr marL="0" indent="0" algn="l" fontAlgn="b">
                        <a:lnSpc>
                          <a:spcPct val="15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ca-E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G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1901573"/>
                  </a:ext>
                </a:extLst>
              </a:tr>
              <a:tr h="468052">
                <a:tc>
                  <a:txBody>
                    <a:bodyPr/>
                    <a:lstStyle/>
                    <a:p>
                      <a:pPr marL="0" indent="0" algn="l" fontAlgn="b">
                        <a:lnSpc>
                          <a:spcPct val="15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en-US" sz="2000" b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Preeclampsia</a:t>
                      </a:r>
                      <a:endParaRPr lang="ca-E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8500564"/>
                  </a:ext>
                </a:extLst>
              </a:tr>
              <a:tr h="468052">
                <a:tc>
                  <a:txBody>
                    <a:bodyPr/>
                    <a:lstStyle/>
                    <a:p>
                      <a:pPr marL="0" indent="0" algn="l" fontAlgn="b">
                        <a:lnSpc>
                          <a:spcPct val="15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en-US" sz="2000" b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Cesarean section</a:t>
                      </a:r>
                      <a:endParaRPr lang="ca-E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5767186"/>
                  </a:ext>
                </a:extLst>
              </a:tr>
              <a:tr h="468052">
                <a:tc>
                  <a:txBody>
                    <a:bodyPr/>
                    <a:lstStyle/>
                    <a:p>
                      <a:pPr marL="0" indent="0" algn="l" fontAlgn="b">
                        <a:lnSpc>
                          <a:spcPct val="15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en-US" sz="2000" b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Preterm delivery</a:t>
                      </a:r>
                      <a:endParaRPr lang="ca-E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2986691"/>
                  </a:ext>
                </a:extLst>
              </a:tr>
              <a:tr h="468052">
                <a:tc>
                  <a:txBody>
                    <a:bodyPr/>
                    <a:lstStyle/>
                    <a:p>
                      <a:pPr marL="0" indent="0" algn="l" fontAlgn="b">
                        <a:lnSpc>
                          <a:spcPct val="15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en-US" sz="2000" b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Labor induction</a:t>
                      </a:r>
                      <a:endParaRPr lang="ca-E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9114110"/>
                  </a:ext>
                </a:extLst>
              </a:tr>
              <a:tr h="468052">
                <a:tc>
                  <a:txBody>
                    <a:bodyPr/>
                    <a:lstStyle/>
                    <a:p>
                      <a:pPr marL="0" indent="0" algn="l" fontAlgn="b">
                        <a:lnSpc>
                          <a:spcPct val="15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en-US" sz="2000" b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Major congenital anomalies</a:t>
                      </a:r>
                      <a:endParaRPr lang="ca-E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1619971"/>
                  </a:ext>
                </a:extLst>
              </a:tr>
              <a:tr h="468052">
                <a:tc>
                  <a:txBody>
                    <a:bodyPr/>
                    <a:lstStyle/>
                    <a:p>
                      <a:pPr marL="0" indent="0" algn="l" fontAlgn="b">
                        <a:lnSpc>
                          <a:spcPct val="15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en-US" sz="2000" b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Perinatal death</a:t>
                      </a:r>
                      <a:endParaRPr lang="ca-E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4113920"/>
                  </a:ext>
                </a:extLst>
              </a:tr>
              <a:tr h="468052">
                <a:tc>
                  <a:txBody>
                    <a:bodyPr/>
                    <a:lstStyle/>
                    <a:p>
                      <a:pPr marL="0" indent="0" algn="l" fontAlgn="b">
                        <a:lnSpc>
                          <a:spcPct val="15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en-US" sz="2000" b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Hyperbilirubinemia</a:t>
                      </a:r>
                      <a:endParaRPr lang="ca-E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0811554"/>
                  </a:ext>
                </a:extLst>
              </a:tr>
              <a:tr h="468052">
                <a:tc>
                  <a:txBody>
                    <a:bodyPr/>
                    <a:lstStyle/>
                    <a:p>
                      <a:pPr marL="0" indent="0" algn="l" fontAlgn="b">
                        <a:lnSpc>
                          <a:spcPct val="150000"/>
                        </a:lnSpc>
                        <a:buFont typeface="Arial" panose="020B0604020202020204" pitchFamily="34" charset="0"/>
                        <a:buNone/>
                      </a:pPr>
                      <a:r>
                        <a:rPr lang="en-US" sz="2000" b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Fetal distress respiratory</a:t>
                      </a:r>
                      <a:endParaRPr lang="ca-E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ca-E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719816"/>
                  </a:ext>
                </a:extLst>
              </a:tr>
            </a:tbl>
          </a:graphicData>
        </a:graphic>
      </p:graphicFrame>
      <p:sp>
        <p:nvSpPr>
          <p:cNvPr id="3" name="2 Rectángulo"/>
          <p:cNvSpPr/>
          <p:nvPr/>
        </p:nvSpPr>
        <p:spPr>
          <a:xfrm>
            <a:off x="0" y="116632"/>
            <a:ext cx="1219199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2: Publication bias estimated by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's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and Egger's test (p value) </a:t>
            </a:r>
            <a:endParaRPr lang="es-E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3 Rectángulo"/>
          <p:cNvSpPr/>
          <p:nvPr/>
        </p:nvSpPr>
        <p:spPr>
          <a:xfrm>
            <a:off x="244690" y="6388019"/>
            <a:ext cx="468102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GA: large for gestational age. SGA: small for gestational age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48043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tge 3">
            <a:extLst>
              <a:ext uri="{FF2B5EF4-FFF2-40B4-BE49-F238E27FC236}">
                <a16:creationId xmlns:a16="http://schemas.microsoft.com/office/drawing/2014/main" id="{933FD9F4-0618-7EBF-8537-50CACC6AE0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5244" y="1177550"/>
            <a:ext cx="7093124" cy="5059762"/>
          </a:xfrm>
          <a:prstGeom prst="rect">
            <a:avLst/>
          </a:prstGeom>
        </p:spPr>
      </p:pic>
      <p:sp>
        <p:nvSpPr>
          <p:cNvPr id="5" name="4 Rectángulo"/>
          <p:cNvSpPr/>
          <p:nvPr/>
        </p:nvSpPr>
        <p:spPr>
          <a:xfrm>
            <a:off x="1430133" y="6453336"/>
            <a:ext cx="21455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GA: large for gestational age </a:t>
            </a:r>
            <a:endParaRPr lang="es-ES" sz="1200" dirty="0"/>
          </a:p>
        </p:txBody>
      </p:sp>
      <p:sp>
        <p:nvSpPr>
          <p:cNvPr id="6" name="1 Título"/>
          <p:cNvSpPr>
            <a:spLocks noGrp="1"/>
          </p:cNvSpPr>
          <p:nvPr>
            <p:ph type="title"/>
          </p:nvPr>
        </p:nvSpPr>
        <p:spPr>
          <a:xfrm>
            <a:off x="0" y="332656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b: funnel plot and </a:t>
            </a:r>
            <a:r>
              <a:rPr lang="en-US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's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gger's test assessing publication bias for LGA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7176120" y="3820978"/>
            <a:ext cx="28803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9</a:t>
            </a: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493</a:t>
            </a:r>
            <a:endParaRPr lang="ca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2711624" y="5805264"/>
            <a:ext cx="2880320" cy="18000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r>
              <a:rPr lang="es-ES" sz="1100" dirty="0" err="1"/>
              <a:t>Studies</a:t>
            </a:r>
            <a:r>
              <a:rPr lang="es-ES" sz="1100" dirty="0"/>
              <a:t> </a:t>
            </a:r>
            <a:r>
              <a:rPr lang="es-ES" sz="1100" dirty="0" err="1"/>
              <a:t>using</a:t>
            </a:r>
            <a:r>
              <a:rPr lang="es-ES" sz="1100" dirty="0"/>
              <a:t> 1T-A1c </a:t>
            </a:r>
            <a:r>
              <a:rPr lang="es-ES" sz="1100" dirty="0" err="1"/>
              <a:t>thershold</a:t>
            </a:r>
            <a:r>
              <a:rPr lang="es-ES" sz="1100" dirty="0"/>
              <a:t> ≤39mmol/mol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6084580" y="5764459"/>
            <a:ext cx="288032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r>
              <a:rPr lang="es-ES" sz="1100" dirty="0" err="1"/>
              <a:t>Studies</a:t>
            </a:r>
            <a:r>
              <a:rPr lang="es-ES" sz="1100" dirty="0"/>
              <a:t> </a:t>
            </a:r>
            <a:r>
              <a:rPr lang="es-ES" sz="1100" dirty="0" err="1"/>
              <a:t>using</a:t>
            </a:r>
            <a:r>
              <a:rPr lang="es-ES" sz="1100" dirty="0"/>
              <a:t> 1T-A1c </a:t>
            </a:r>
            <a:r>
              <a:rPr lang="es-ES" sz="1100" dirty="0" err="1"/>
              <a:t>thershold</a:t>
            </a:r>
            <a:r>
              <a:rPr lang="es-ES" sz="1100" dirty="0"/>
              <a:t> &gt;39mmol/mol</a:t>
            </a:r>
          </a:p>
        </p:txBody>
      </p:sp>
    </p:spTree>
    <p:extLst>
      <p:ext uri="{BB962C8B-B14F-4D97-AF65-F5344CB8AC3E}">
        <p14:creationId xmlns:p14="http://schemas.microsoft.com/office/powerpoint/2010/main" val="31011993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1 Título"/>
          <p:cNvSpPr>
            <a:spLocks noGrp="1"/>
          </p:cNvSpPr>
          <p:nvPr>
            <p:ph type="title"/>
          </p:nvPr>
        </p:nvSpPr>
        <p:spPr>
          <a:xfrm>
            <a:off x="0" y="260648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a: Forest plot showing the results of meta-analyses for macrosomia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1404" y="836712"/>
            <a:ext cx="10729192" cy="50235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758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1 Título"/>
          <p:cNvSpPr>
            <a:spLocks noGrp="1"/>
          </p:cNvSpPr>
          <p:nvPr>
            <p:ph type="title"/>
          </p:nvPr>
        </p:nvSpPr>
        <p:spPr>
          <a:xfrm>
            <a:off x="0" y="260648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b: funnel plot and </a:t>
            </a:r>
            <a:r>
              <a:rPr lang="en-US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's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gger's test assessing publication bias for macrosomia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upo 4"/>
          <p:cNvGrpSpPr/>
          <p:nvPr/>
        </p:nvGrpSpPr>
        <p:grpSpPr>
          <a:xfrm>
            <a:off x="2855640" y="1268760"/>
            <a:ext cx="7200800" cy="4630638"/>
            <a:chOff x="2855640" y="1268760"/>
            <a:chExt cx="7200800" cy="4630638"/>
          </a:xfrm>
        </p:grpSpPr>
        <p:pic>
          <p:nvPicPr>
            <p:cNvPr id="2" name="Imagen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55640" y="1268760"/>
              <a:ext cx="6491548" cy="4630638"/>
            </a:xfrm>
            <a:prstGeom prst="rect">
              <a:avLst/>
            </a:prstGeom>
          </p:spPr>
        </p:pic>
        <p:sp>
          <p:nvSpPr>
            <p:cNvPr id="6" name="QuadreDeText 5">
              <a:extLst>
                <a:ext uri="{FF2B5EF4-FFF2-40B4-BE49-F238E27FC236}">
                  <a16:creationId xmlns:a16="http://schemas.microsoft.com/office/drawing/2014/main" id="{EE38BB84-1095-A12C-E1C4-C273EE07ED11}"/>
                </a:ext>
              </a:extLst>
            </p:cNvPr>
            <p:cNvSpPr txBox="1"/>
            <p:nvPr/>
          </p:nvSpPr>
          <p:spPr>
            <a:xfrm>
              <a:off x="6888088" y="3933056"/>
              <a:ext cx="31683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gger’s</a:t>
              </a:r>
              <a:r>
                <a:rPr lang="es-E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est p </a:t>
              </a:r>
              <a:r>
                <a:rPr lang="es-E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alue</a:t>
              </a:r>
              <a:r>
                <a:rPr lang="es-E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487</a:t>
              </a:r>
            </a:p>
            <a:p>
              <a:r>
                <a:rPr lang="es-E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egg’s</a:t>
              </a:r>
              <a:r>
                <a:rPr lang="es-E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est p </a:t>
              </a:r>
              <a:r>
                <a:rPr lang="es-E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alue</a:t>
              </a:r>
              <a:r>
                <a:rPr lang="es-E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421</a:t>
              </a:r>
              <a:endPara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" name="Imagen 3"/>
            <p:cNvPicPr>
              <a:picLocks noChangeAspect="1"/>
            </p:cNvPicPr>
            <p:nvPr/>
          </p:nvPicPr>
          <p:blipFill rotWithShape="1">
            <a:blip r:embed="rId3"/>
            <a:srcRect l="34250" t="75200" r="9051" b="17800"/>
            <a:stretch/>
          </p:blipFill>
          <p:spPr>
            <a:xfrm>
              <a:off x="2856334" y="5354510"/>
              <a:ext cx="6490854" cy="45075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6331688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1 Título"/>
          <p:cNvSpPr>
            <a:spLocks noGrp="1"/>
          </p:cNvSpPr>
          <p:nvPr>
            <p:ph type="title"/>
          </p:nvPr>
        </p:nvSpPr>
        <p:spPr>
          <a:xfrm>
            <a:off x="0" y="692696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a: Forest plot showing the results of meta-analyses for preeclampsia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2741" y="1268760"/>
            <a:ext cx="10446518" cy="4118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17742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1 Título"/>
          <p:cNvSpPr>
            <a:spLocks noGrp="1"/>
          </p:cNvSpPr>
          <p:nvPr>
            <p:ph type="title"/>
          </p:nvPr>
        </p:nvSpPr>
        <p:spPr>
          <a:xfrm>
            <a:off x="0" y="332656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b: funnel plot and </a:t>
            </a:r>
            <a:r>
              <a:rPr lang="en-US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's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gger's test assessing publication bias for preeclampsia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upo 2"/>
          <p:cNvGrpSpPr/>
          <p:nvPr/>
        </p:nvGrpSpPr>
        <p:grpSpPr>
          <a:xfrm>
            <a:off x="2567608" y="1268760"/>
            <a:ext cx="6840000" cy="4879200"/>
            <a:chOff x="2567608" y="1268760"/>
            <a:chExt cx="6840000" cy="4879200"/>
          </a:xfrm>
        </p:grpSpPr>
        <p:pic>
          <p:nvPicPr>
            <p:cNvPr id="4" name="Imatge 3">
              <a:extLst>
                <a:ext uri="{FF2B5EF4-FFF2-40B4-BE49-F238E27FC236}">
                  <a16:creationId xmlns:a16="http://schemas.microsoft.com/office/drawing/2014/main" id="{CD5BBFA8-258D-3E3D-7FAF-C1CD75D7AE7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67608" y="1268760"/>
              <a:ext cx="6840000" cy="4879200"/>
            </a:xfrm>
            <a:prstGeom prst="rect">
              <a:avLst/>
            </a:prstGeom>
          </p:spPr>
        </p:pic>
        <p:pic>
          <p:nvPicPr>
            <p:cNvPr id="8" name="Imagen 7"/>
            <p:cNvPicPr>
              <a:picLocks noChangeAspect="1"/>
            </p:cNvPicPr>
            <p:nvPr/>
          </p:nvPicPr>
          <p:blipFill rotWithShape="1">
            <a:blip r:embed="rId3"/>
            <a:srcRect l="34250" t="75200" r="9051" b="17800"/>
            <a:stretch/>
          </p:blipFill>
          <p:spPr>
            <a:xfrm>
              <a:off x="2742181" y="5589240"/>
              <a:ext cx="6490854" cy="450754"/>
            </a:xfrm>
            <a:prstGeom prst="rect">
              <a:avLst/>
            </a:prstGeom>
          </p:spPr>
        </p:pic>
      </p:grpSp>
      <p:sp>
        <p:nvSpPr>
          <p:cNvPr id="7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8040216" y="3068960"/>
            <a:ext cx="31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38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24</a:t>
            </a:r>
          </a:p>
        </p:txBody>
      </p:sp>
    </p:spTree>
    <p:extLst>
      <p:ext uri="{BB962C8B-B14F-4D97-AF65-F5344CB8AC3E}">
        <p14:creationId xmlns:p14="http://schemas.microsoft.com/office/powerpoint/2010/main" val="18330691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1 Título"/>
          <p:cNvSpPr>
            <a:spLocks noGrp="1"/>
          </p:cNvSpPr>
          <p:nvPr>
            <p:ph type="title"/>
          </p:nvPr>
        </p:nvSpPr>
        <p:spPr>
          <a:xfrm>
            <a:off x="0" y="116632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a: Forest plot showing the results of meta-analyses for SGA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5 Rectángulo"/>
          <p:cNvSpPr/>
          <p:nvPr/>
        </p:nvSpPr>
        <p:spPr>
          <a:xfrm>
            <a:off x="695400" y="6392361"/>
            <a:ext cx="20874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GA: small for gestational age</a:t>
            </a:r>
            <a:endParaRPr lang="es-ES" sz="1200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9376" y="764704"/>
            <a:ext cx="10585176" cy="49561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08973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1 Título"/>
          <p:cNvSpPr>
            <a:spLocks noGrp="1"/>
          </p:cNvSpPr>
          <p:nvPr>
            <p:ph type="title"/>
          </p:nvPr>
        </p:nvSpPr>
        <p:spPr>
          <a:xfrm>
            <a:off x="0" y="116632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b: funnel plot and </a:t>
            </a:r>
            <a:r>
              <a:rPr lang="en-US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's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gger's test assessing publication bias for SGA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6 Rectángulo"/>
          <p:cNvSpPr/>
          <p:nvPr/>
        </p:nvSpPr>
        <p:spPr>
          <a:xfrm>
            <a:off x="2064353" y="6104329"/>
            <a:ext cx="20874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GA: small for gestational age</a:t>
            </a:r>
            <a:endParaRPr lang="es-ES" sz="1200" dirty="0"/>
          </a:p>
        </p:txBody>
      </p:sp>
      <p:sp>
        <p:nvSpPr>
          <p:cNvPr id="8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7320136" y="3615407"/>
            <a:ext cx="31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17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55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2639616" y="1070080"/>
            <a:ext cx="6840000" cy="4879200"/>
            <a:chOff x="2639616" y="1070080"/>
            <a:chExt cx="6840000" cy="4879200"/>
          </a:xfrm>
        </p:grpSpPr>
        <p:pic>
          <p:nvPicPr>
            <p:cNvPr id="5" name="Imatge 4">
              <a:extLst>
                <a:ext uri="{FF2B5EF4-FFF2-40B4-BE49-F238E27FC236}">
                  <a16:creationId xmlns:a16="http://schemas.microsoft.com/office/drawing/2014/main" id="{442A533E-87AA-BE89-B287-54015A47744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39616" y="1070080"/>
              <a:ext cx="6840000" cy="4879200"/>
            </a:xfrm>
            <a:prstGeom prst="rect">
              <a:avLst/>
            </a:prstGeom>
          </p:spPr>
        </p:pic>
        <p:pic>
          <p:nvPicPr>
            <p:cNvPr id="9" name="Imagen 8"/>
            <p:cNvPicPr>
              <a:picLocks noChangeAspect="1"/>
            </p:cNvPicPr>
            <p:nvPr/>
          </p:nvPicPr>
          <p:blipFill rotWithShape="1">
            <a:blip r:embed="rId3"/>
            <a:srcRect l="34250" t="75200" r="9051" b="17800"/>
            <a:stretch/>
          </p:blipFill>
          <p:spPr>
            <a:xfrm>
              <a:off x="2711624" y="5350674"/>
              <a:ext cx="6696744" cy="454590"/>
            </a:xfrm>
            <a:prstGeom prst="rect">
              <a:avLst/>
            </a:prstGeom>
          </p:spPr>
        </p:pic>
      </p:grpSp>
      <p:sp>
        <p:nvSpPr>
          <p:cNvPr id="10" name="QuadreDeText 5">
            <a:extLst>
              <a:ext uri="{FF2B5EF4-FFF2-40B4-BE49-F238E27FC236}">
                <a16:creationId xmlns:a16="http://schemas.microsoft.com/office/drawing/2014/main" id="{EE38BB84-1095-A12C-E1C4-C273EE07ED11}"/>
              </a:ext>
            </a:extLst>
          </p:cNvPr>
          <p:cNvSpPr txBox="1"/>
          <p:nvPr/>
        </p:nvSpPr>
        <p:spPr>
          <a:xfrm>
            <a:off x="7472536" y="3767807"/>
            <a:ext cx="3168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ger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17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gg’s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 p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ca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55</a:t>
            </a:r>
          </a:p>
        </p:txBody>
      </p:sp>
    </p:spTree>
    <p:extLst>
      <p:ext uri="{BB962C8B-B14F-4D97-AF65-F5344CB8AC3E}">
        <p14:creationId xmlns:p14="http://schemas.microsoft.com/office/powerpoint/2010/main" val="23408825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1 Título"/>
          <p:cNvSpPr>
            <a:spLocks noGrp="1"/>
          </p:cNvSpPr>
          <p:nvPr>
            <p:ph type="title"/>
          </p:nvPr>
        </p:nvSpPr>
        <p:spPr>
          <a:xfrm>
            <a:off x="0" y="188640"/>
            <a:ext cx="12192000" cy="576064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a: Forest plot showing the results of meta-analyses for preterm delivery</a:t>
            </a:r>
            <a:endParaRPr lang="es-E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5400" y="764704"/>
            <a:ext cx="10369152" cy="47693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99223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7f1ed342-24c2-4e16-a0eb-607b3883afae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8610CE5B95FC2946A6A1CAC8734F4D79" ma:contentTypeVersion="16" ma:contentTypeDescription="Crear nuevo documento." ma:contentTypeScope="" ma:versionID="53c339300c8832993e1bef13b758034a">
  <xsd:schema xmlns:xsd="http://www.w3.org/2001/XMLSchema" xmlns:xs="http://www.w3.org/2001/XMLSchema" xmlns:p="http://schemas.microsoft.com/office/2006/metadata/properties" xmlns:ns3="52b31045-1fd7-4970-b904-03ffeb508cc7" xmlns:ns4="7f1ed342-24c2-4e16-a0eb-607b3883afae" targetNamespace="http://schemas.microsoft.com/office/2006/metadata/properties" ma:root="true" ma:fieldsID="d483c44c64c55bccdd164f70f229ddba" ns3:_="" ns4:_="">
    <xsd:import namespace="52b31045-1fd7-4970-b904-03ffeb508cc7"/>
    <xsd:import namespace="7f1ed342-24c2-4e16-a0eb-607b3883afae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ServiceDateTaken" minOccurs="0"/>
                <xsd:element ref="ns4:MediaServiceLocation" minOccurs="0"/>
                <xsd:element ref="ns4:MediaLengthInSeconds" minOccurs="0"/>
                <xsd:element ref="ns4:_activity" minOccurs="0"/>
                <xsd:element ref="ns4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2b31045-1fd7-4970-b904-03ffeb508cc7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f1ed342-24c2-4e16-a0eb-607b3883afa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D74D9CD-86B5-4D8D-9441-55C6829F6EA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FDE1D41-817C-4464-8B40-A4D867E76529}">
  <ds:schemaRefs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52b31045-1fd7-4970-b904-03ffeb508cc7"/>
    <ds:schemaRef ds:uri="http://purl.org/dc/terms/"/>
    <ds:schemaRef ds:uri="7f1ed342-24c2-4e16-a0eb-607b3883afae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506E1CF0-0056-46B8-A619-9410D68DD7C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2b31045-1fd7-4970-b904-03ffeb508cc7"/>
    <ds:schemaRef ds:uri="7f1ed342-24c2-4e16-a0eb-607b3883afa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610</Words>
  <Application>Microsoft Office PowerPoint</Application>
  <PresentationFormat>Widescreen</PresentationFormat>
  <Paragraphs>94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3" baseType="lpstr">
      <vt:lpstr>Arial</vt:lpstr>
      <vt:lpstr>Calibri</vt:lpstr>
      <vt:lpstr>Times New Roman</vt:lpstr>
      <vt:lpstr>Tema de Office</vt:lpstr>
      <vt:lpstr>Figure S1a: Forest plot showing the results of meta-analyses for LGA</vt:lpstr>
      <vt:lpstr>Figure S1b: funnel plot and Begg's and Egger's test assessing publication bias for LGA</vt:lpstr>
      <vt:lpstr>Figure S2a: Forest plot showing the results of meta-analyses for macrosomia</vt:lpstr>
      <vt:lpstr>Figure S2b: funnel plot and Begg's and Egger's test assessing publication bias for macrosomia</vt:lpstr>
      <vt:lpstr>Figure S3a: Forest plot showing the results of meta-analyses for preeclampsia</vt:lpstr>
      <vt:lpstr>Figure S3b: funnel plot and Begg's and Egger's test assessing publication bias for preeclampsia</vt:lpstr>
      <vt:lpstr>Figure S4a: Forest plot showing the results of meta-analyses for SGA</vt:lpstr>
      <vt:lpstr>Figure S4b: funnel plot and Begg's and Egger's test assessing publication bias for SGA</vt:lpstr>
      <vt:lpstr>Figure S5a: Forest plot showing the results of meta-analyses for preterm delivery</vt:lpstr>
      <vt:lpstr>Figure S5b: funnel plot and Begg's and Egger's test assessing publication bias for preterm delivery</vt:lpstr>
      <vt:lpstr>Figure S6a: Forest plot showing the results of meta-analyses for cesarean section</vt:lpstr>
      <vt:lpstr>Figure S6b: funnel plot and Begg's and Egger's test assessing publication bias for cesarean section</vt:lpstr>
      <vt:lpstr>Figure S7a: Forest plot showing the results of meta-analyses for labor induction</vt:lpstr>
      <vt:lpstr>Figure S7b: funnel plot and Begg's and Egger's test assessing publication bias for labor induction</vt:lpstr>
      <vt:lpstr>Figure S8a: Forest plot showing the results of meta-analyses for major congenital anomalies</vt:lpstr>
      <vt:lpstr>Figure S9a: Forest plot showing the results of meta-analyses for perinatal death</vt:lpstr>
      <vt:lpstr>Figure S10a: Forest plot showing the results of meta-analyses for hyperbilirubinemia</vt:lpstr>
      <vt:lpstr>Figure S11a: Forest plot showing the results of meta-analyses for fetal respiratory distress</vt:lpstr>
      <vt:lpstr>PowerPoint Presentation</vt:lpstr>
    </vt:vector>
  </TitlesOfParts>
  <Company>psma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ultats MA</dc:title>
  <dc:creator>David Benaiges Boix</dc:creator>
  <cp:lastModifiedBy>MDPI</cp:lastModifiedBy>
  <cp:revision>27</cp:revision>
  <dcterms:created xsi:type="dcterms:W3CDTF">2022-11-08T15:39:09Z</dcterms:created>
  <dcterms:modified xsi:type="dcterms:W3CDTF">2024-03-17T03:05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610CE5B95FC2946A6A1CAC8734F4D79</vt:lpwstr>
  </property>
</Properties>
</file>